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7B0B0"/>
    <a:srgbClr val="FF6699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348CA0-68D7-4416-BA67-5B7B94306D40}" v="2" dt="2023-10-16T16:47:57.55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1" d="100"/>
          <a:sy n="91" d="100"/>
        </p:scale>
        <p:origin x="28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3543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857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7523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0384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512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1595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7967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2642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6730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2932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4930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65F6F-A5E6-45E7-A2A8-8085802032E9}" type="datetimeFigureOut">
              <a:rPr lang="de-DE" smtClean="0"/>
              <a:t>17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AC28A-0CA9-4A90-B85F-EBA02DA555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58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D134D33D-CC69-8222-A55C-3AB3215034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6988525"/>
              </p:ext>
            </p:extLst>
          </p:nvPr>
        </p:nvGraphicFramePr>
        <p:xfrm>
          <a:off x="502920" y="978408"/>
          <a:ext cx="558927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618">
                  <a:extLst>
                    <a:ext uri="{9D8B030D-6E8A-4147-A177-3AD203B41FA5}">
                      <a16:colId xmlns:a16="http://schemas.microsoft.com/office/drawing/2014/main" val="1627182887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970203570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05625835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3688904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813034049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14969963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21971438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82780436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83510568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403712076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1109521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938575128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29343040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63230521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60071618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2</a:t>
                      </a:r>
                    </a:p>
                  </a:txBody>
                  <a:tcPr>
                    <a:solidFill>
                      <a:srgbClr val="D7B0B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7114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>
                    <a:solidFill>
                      <a:srgbClr val="D7B0B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H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6397902"/>
                  </a:ext>
                </a:extLst>
              </a:tr>
            </a:tbl>
          </a:graphicData>
        </a:graphic>
      </p:graphicFrame>
      <p:graphicFrame>
        <p:nvGraphicFramePr>
          <p:cNvPr id="13" name="Tabelle 12">
            <a:extLst>
              <a:ext uri="{FF2B5EF4-FFF2-40B4-BE49-F238E27FC236}">
                <a16:creationId xmlns:a16="http://schemas.microsoft.com/office/drawing/2014/main" id="{5FC2DFF6-D8E0-D93E-2C1A-7A4326B1B5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3824787"/>
              </p:ext>
            </p:extLst>
          </p:nvPr>
        </p:nvGraphicFramePr>
        <p:xfrm>
          <a:off x="502920" y="1951145"/>
          <a:ext cx="558927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618">
                  <a:extLst>
                    <a:ext uri="{9D8B030D-6E8A-4147-A177-3AD203B41FA5}">
                      <a16:colId xmlns:a16="http://schemas.microsoft.com/office/drawing/2014/main" val="1627182887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970203570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05625835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3688904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813034049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14969963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21971438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82780436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83510568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403712076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1109521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938575128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29343040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63230521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60071618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7114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P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6397902"/>
                  </a:ext>
                </a:extLst>
              </a:tr>
            </a:tbl>
          </a:graphicData>
        </a:graphic>
      </p:graphicFrame>
      <p:graphicFrame>
        <p:nvGraphicFramePr>
          <p:cNvPr id="14" name="Tabelle 13">
            <a:extLst>
              <a:ext uri="{FF2B5EF4-FFF2-40B4-BE49-F238E27FC236}">
                <a16:creationId xmlns:a16="http://schemas.microsoft.com/office/drawing/2014/main" id="{31883D12-1FE1-BF3D-B7B8-84ACD58355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9467689"/>
              </p:ext>
            </p:extLst>
          </p:nvPr>
        </p:nvGraphicFramePr>
        <p:xfrm>
          <a:off x="502920" y="2929128"/>
          <a:ext cx="558927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618">
                  <a:extLst>
                    <a:ext uri="{9D8B030D-6E8A-4147-A177-3AD203B41FA5}">
                      <a16:colId xmlns:a16="http://schemas.microsoft.com/office/drawing/2014/main" val="1627182887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970203570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05625835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3688904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813034049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14969963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21971438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82780436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83510568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403712076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1109521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938575128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29343040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63230521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60071618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7114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6397902"/>
                  </a:ext>
                </a:extLst>
              </a:tr>
            </a:tbl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:a16="http://schemas.microsoft.com/office/drawing/2014/main" id="{8F58AAB2-EABD-23B7-468B-70CC0FCFC5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6635226"/>
              </p:ext>
            </p:extLst>
          </p:nvPr>
        </p:nvGraphicFramePr>
        <p:xfrm>
          <a:off x="502920" y="3904488"/>
          <a:ext cx="558927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618">
                  <a:extLst>
                    <a:ext uri="{9D8B030D-6E8A-4147-A177-3AD203B41FA5}">
                      <a16:colId xmlns:a16="http://schemas.microsoft.com/office/drawing/2014/main" val="1627182887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970203570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05625835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3688904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813034049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14969963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21971438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82780436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83510568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403712076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1109521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938575128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29343040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63230521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60071618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7114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6397902"/>
                  </a:ext>
                </a:extLst>
              </a:tr>
            </a:tbl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:a16="http://schemas.microsoft.com/office/drawing/2014/main" id="{04C96F5F-579B-CB6B-F594-CB83960849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558050"/>
              </p:ext>
            </p:extLst>
          </p:nvPr>
        </p:nvGraphicFramePr>
        <p:xfrm>
          <a:off x="502920" y="4879848"/>
          <a:ext cx="558927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618">
                  <a:extLst>
                    <a:ext uri="{9D8B030D-6E8A-4147-A177-3AD203B41FA5}">
                      <a16:colId xmlns:a16="http://schemas.microsoft.com/office/drawing/2014/main" val="1627182887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970203570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05625835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3688904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813034049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14969963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21971438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82780436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83510568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403712076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1109521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938575128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29343040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63230521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60071618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6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2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3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4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5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7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8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69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2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3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4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5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77114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W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63979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b="1" dirty="0">
                          <a:solidFill>
                            <a:schemeClr val="tx1"/>
                          </a:solidFill>
                        </a:rPr>
                        <a:t>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b="1" dirty="0">
                          <a:solidFill>
                            <a:schemeClr val="tx1"/>
                          </a:solidFill>
                        </a:rPr>
                        <a:t>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b="1" dirty="0">
                          <a:solidFill>
                            <a:schemeClr val="tx1"/>
                          </a:solidFill>
                        </a:rPr>
                        <a:t>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14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2308975"/>
                  </a:ext>
                </a:extLst>
              </a:tr>
            </a:tbl>
          </a:graphicData>
        </a:graphic>
      </p:graphicFrame>
      <p:graphicFrame>
        <p:nvGraphicFramePr>
          <p:cNvPr id="17" name="Tabelle 16">
            <a:extLst>
              <a:ext uri="{FF2B5EF4-FFF2-40B4-BE49-F238E27FC236}">
                <a16:creationId xmlns:a16="http://schemas.microsoft.com/office/drawing/2014/main" id="{9FAF5AB5-4045-3044-E648-D90B9CF385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3038386"/>
              </p:ext>
            </p:extLst>
          </p:nvPr>
        </p:nvGraphicFramePr>
        <p:xfrm>
          <a:off x="502920" y="6226048"/>
          <a:ext cx="558927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618">
                  <a:extLst>
                    <a:ext uri="{9D8B030D-6E8A-4147-A177-3AD203B41FA5}">
                      <a16:colId xmlns:a16="http://schemas.microsoft.com/office/drawing/2014/main" val="1627182887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970203570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05625835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3688904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813034049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14969963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21971438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827804365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835105686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4037120763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181109521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2938575128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29343040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3632305212"/>
                    </a:ext>
                  </a:extLst>
                </a:gridCol>
                <a:gridCol w="372618">
                  <a:extLst>
                    <a:ext uri="{9D8B030D-6E8A-4147-A177-3AD203B41FA5}">
                      <a16:colId xmlns:a16="http://schemas.microsoft.com/office/drawing/2014/main" val="60071618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9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7114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400" dirty="0"/>
                        <a:t>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63979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05746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9D7E38B79A148A4995A9BF8C44953F0A" ma:contentTypeVersion="4" ma:contentTypeDescription="Ein neues Dokument erstellen." ma:contentTypeScope="" ma:versionID="eb389c928e043328b67efbeaf7c947e2">
  <xsd:schema xmlns:xsd="http://www.w3.org/2001/XMLSchema" xmlns:xs="http://www.w3.org/2001/XMLSchema" xmlns:p="http://schemas.microsoft.com/office/2006/metadata/properties" xmlns:ns3="d38e3441-8724-4120-b53a-54a1f034055b" targetNamespace="http://schemas.microsoft.com/office/2006/metadata/properties" ma:root="true" ma:fieldsID="894541204a1bded9ce6724fd812fe63a" ns3:_="">
    <xsd:import namespace="d38e3441-8724-4120-b53a-54a1f034055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38e3441-8724-4120-b53a-54a1f034055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38e3441-8724-4120-b53a-54a1f034055b" xsi:nil="true"/>
  </documentManagement>
</p:properties>
</file>

<file path=customXml/itemProps1.xml><?xml version="1.0" encoding="utf-8"?>
<ds:datastoreItem xmlns:ds="http://schemas.openxmlformats.org/officeDocument/2006/customXml" ds:itemID="{00718C15-E587-46ED-A7B0-AA0DD1E37F2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F15945D-5FE1-4F1D-A1C0-CD5411C171F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38e3441-8724-4120-b53a-54a1f034055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8026EF9-C685-43AA-9BE7-11D1C99EA248}">
  <ds:schemaRefs>
    <ds:schemaRef ds:uri="http://schemas.openxmlformats.org/package/2006/metadata/core-properties"/>
    <ds:schemaRef ds:uri="http://purl.org/dc/elements/1.1/"/>
    <ds:schemaRef ds:uri="http://purl.org/dc/dcmitype/"/>
    <ds:schemaRef ds:uri="d38e3441-8724-4120-b53a-54a1f034055b"/>
    <ds:schemaRef ds:uri="http://schemas.microsoft.com/office/2006/metadata/properties"/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83</Words>
  <Application>Microsoft Office PowerPoint</Application>
  <PresentationFormat>A4-Papier (210 x 297 mm)</PresentationFormat>
  <Paragraphs>18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ise Hohensee</dc:creator>
  <cp:lastModifiedBy>Blohm, Ulrike</cp:lastModifiedBy>
  <cp:revision>2</cp:revision>
  <dcterms:created xsi:type="dcterms:W3CDTF">2023-10-16T14:16:02Z</dcterms:created>
  <dcterms:modified xsi:type="dcterms:W3CDTF">2023-10-17T17:44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7E38B79A148A4995A9BF8C44953F0A</vt:lpwstr>
  </property>
</Properties>
</file>